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9" r:id="rId2"/>
    <p:sldId id="268" r:id="rId3"/>
    <p:sldId id="267" r:id="rId4"/>
    <p:sldId id="257" r:id="rId5"/>
    <p:sldId id="260" r:id="rId6"/>
    <p:sldId id="261" r:id="rId7"/>
    <p:sldId id="264" r:id="rId8"/>
    <p:sldId id="266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therine.verfaillie@med.kuleuven.be" initials="c" lastIdx="5" clrIdx="0">
    <p:extLst>
      <p:ext uri="{19B8F6BF-5375-455C-9EA6-DF929625EA0E}">
        <p15:presenceInfo xmlns:p15="http://schemas.microsoft.com/office/powerpoint/2012/main" userId="catherine.verfaillie@med.kuleuven.be" providerId="None"/>
      </p:ext>
    </p:extLst>
  </p:cmAuthor>
  <p:cmAuthor id="2" name="Jonathan De Smedt" initials="JDS" lastIdx="3" clrIdx="1">
    <p:extLst>
      <p:ext uri="{19B8F6BF-5375-455C-9EA6-DF929625EA0E}">
        <p15:presenceInfo xmlns:p15="http://schemas.microsoft.com/office/powerpoint/2012/main" userId="S-1-5-21-4060015860-3155939536-3220560164-42793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48" d="100"/>
          <a:sy n="48" d="100"/>
        </p:scale>
        <p:origin x="2168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2312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7986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7041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8019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105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9060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2968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997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0584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7420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7750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96B6E0-D282-4C00-AB90-63DBA0A5EF8E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1289A-4DEB-4DE4-8059-D71E9E12A2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39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microsoft.com/office/2007/relationships/hdphoto" Target="../media/hdphoto1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tiff"/><Relationship Id="rId7" Type="http://schemas.openxmlformats.org/officeDocument/2006/relationships/image" Target="../media/image21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5" Type="http://schemas.microsoft.com/office/2007/relationships/hdphoto" Target="../media/hdphoto3.wdp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6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tiff"/><Relationship Id="rId13" Type="http://schemas.openxmlformats.org/officeDocument/2006/relationships/image" Target="../media/image42.tiff"/><Relationship Id="rId3" Type="http://schemas.openxmlformats.org/officeDocument/2006/relationships/image" Target="../media/image17.tiff"/><Relationship Id="rId7" Type="http://schemas.openxmlformats.org/officeDocument/2006/relationships/image" Target="../media/image19.tiff"/><Relationship Id="rId12" Type="http://schemas.openxmlformats.org/officeDocument/2006/relationships/image" Target="../media/image41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11" Type="http://schemas.openxmlformats.org/officeDocument/2006/relationships/image" Target="../media/image21.tiff"/><Relationship Id="rId5" Type="http://schemas.openxmlformats.org/officeDocument/2006/relationships/image" Target="../media/image38.tiff"/><Relationship Id="rId10" Type="http://schemas.openxmlformats.org/officeDocument/2006/relationships/image" Target="../media/image20.tiff"/><Relationship Id="rId4" Type="http://schemas.openxmlformats.org/officeDocument/2006/relationships/image" Target="../media/image37.tiff"/><Relationship Id="rId9" Type="http://schemas.openxmlformats.org/officeDocument/2006/relationships/image" Target="../media/image4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505466" y="3180801"/>
            <a:ext cx="52273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/>
            </a:lvl1pPr>
          </a:lstStyle>
          <a:p>
            <a:pPr algn="just"/>
            <a:r>
              <a:rPr lang="en-US" sz="900" b="1" dirty="0"/>
              <a:t>Supplementary  Figure 1. Effect of VEGFA addition to the culture media</a:t>
            </a:r>
          </a:p>
          <a:p>
            <a:pPr algn="just"/>
            <a:r>
              <a:rPr lang="en-US" sz="900" dirty="0"/>
              <a:t>VEGFA (50ng/ml) was added to the culture media of ETV2-SPI1-ECs, starting from day 6 of differentiation. (N=7 for samples without VEGFA, N=4 for samples with VEGFA) (Student’s T-test; * p&lt;0.05, ** p&lt;0.01, *** p&lt;0.001, NS: not significant, ND: not detectable)</a:t>
            </a:r>
            <a:endParaRPr lang="en-GB" sz="9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466" y="397043"/>
            <a:ext cx="5048379" cy="27867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98023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2948" y="454944"/>
            <a:ext cx="1604827" cy="2194575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135" y="454088"/>
            <a:ext cx="1605454" cy="219543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43542" y="4818137"/>
            <a:ext cx="6360458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/>
            </a:lvl1pPr>
          </a:lstStyle>
          <a:p>
            <a:pPr algn="just"/>
            <a:r>
              <a:rPr lang="en-US" sz="900" b="1" dirty="0"/>
              <a:t>Supplementary  Figure 2. Effect of substituting </a:t>
            </a:r>
            <a:r>
              <a:rPr lang="en-US" sz="900" b="1" i="1" dirty="0"/>
              <a:t>ETV2</a:t>
            </a:r>
            <a:r>
              <a:rPr lang="en-US" sz="900" b="1" dirty="0"/>
              <a:t> overexpression by lentiviral overexpression of </a:t>
            </a:r>
            <a:r>
              <a:rPr lang="en-US" sz="900" b="1" i="1" dirty="0"/>
              <a:t>FLI1</a:t>
            </a:r>
            <a:r>
              <a:rPr lang="en-US" sz="900" b="1" dirty="0"/>
              <a:t> and </a:t>
            </a:r>
            <a:r>
              <a:rPr lang="en-US" sz="900" b="1" i="1" dirty="0"/>
              <a:t>ERG</a:t>
            </a:r>
            <a:r>
              <a:rPr lang="en-US" sz="900" b="1" dirty="0"/>
              <a:t> </a:t>
            </a:r>
          </a:p>
          <a:p>
            <a:pPr algn="just"/>
            <a:r>
              <a:rPr lang="en-US" sz="900" b="1" dirty="0"/>
              <a:t>A. </a:t>
            </a:r>
            <a:r>
              <a:rPr lang="en-US" sz="900" dirty="0"/>
              <a:t>ETV2-ECs were co-transduced with </a:t>
            </a:r>
            <a:r>
              <a:rPr lang="en-US" sz="900" i="1" dirty="0"/>
              <a:t>SPI1-</a:t>
            </a:r>
            <a:r>
              <a:rPr lang="en-US" sz="900" dirty="0"/>
              <a:t> and </a:t>
            </a:r>
            <a:r>
              <a:rPr lang="en-US" sz="900" i="1" dirty="0"/>
              <a:t>FLI1-</a:t>
            </a:r>
            <a:r>
              <a:rPr lang="en-US" sz="900" dirty="0"/>
              <a:t> and/or </a:t>
            </a:r>
            <a:r>
              <a:rPr lang="en-US" sz="900" i="1" dirty="0"/>
              <a:t>ERG-</a:t>
            </a:r>
            <a:r>
              <a:rPr lang="en-US" sz="900" dirty="0"/>
              <a:t> encoding lentiviral vectors, with or without doxycycline-induced </a:t>
            </a:r>
            <a:r>
              <a:rPr lang="en-US" sz="900" i="1" dirty="0"/>
              <a:t>ETV2</a:t>
            </a:r>
            <a:r>
              <a:rPr lang="en-US" sz="900" dirty="0"/>
              <a:t> overexpression. The expression of endothelial TFs </a:t>
            </a:r>
            <a:r>
              <a:rPr lang="en-US" sz="900" i="1" dirty="0"/>
              <a:t>ETV2</a:t>
            </a:r>
            <a:r>
              <a:rPr lang="en-US" sz="900" dirty="0"/>
              <a:t>, </a:t>
            </a:r>
            <a:r>
              <a:rPr lang="en-US" sz="900" i="1" dirty="0"/>
              <a:t>ERG</a:t>
            </a:r>
            <a:r>
              <a:rPr lang="en-US" sz="900" dirty="0"/>
              <a:t>, and  </a:t>
            </a:r>
            <a:r>
              <a:rPr lang="en-US" sz="900" i="1" dirty="0"/>
              <a:t>FLI1</a:t>
            </a:r>
            <a:r>
              <a:rPr lang="en-US" sz="900" dirty="0"/>
              <a:t>, and the endothelial marker </a:t>
            </a:r>
            <a:r>
              <a:rPr lang="en-US" sz="900" i="1" dirty="0"/>
              <a:t>PECAM1</a:t>
            </a:r>
            <a:r>
              <a:rPr lang="en-US" sz="900" dirty="0"/>
              <a:t> is shown.  </a:t>
            </a:r>
            <a:r>
              <a:rPr lang="en-US" sz="900" b="1" dirty="0"/>
              <a:t>B. </a:t>
            </a:r>
            <a:r>
              <a:rPr lang="en-US" sz="900" dirty="0"/>
              <a:t>Heatmap indicating in red genes that were significantly (p&lt;0.05) differentially expressed compared to ETV2-ECs transduced with S</a:t>
            </a:r>
            <a:r>
              <a:rPr lang="en-US" sz="900" i="1" dirty="0"/>
              <a:t>PI1</a:t>
            </a:r>
            <a:r>
              <a:rPr lang="en-US" sz="900" dirty="0"/>
              <a:t>-encoding lentiviral vector and exposed to doxycycline.  </a:t>
            </a:r>
            <a:r>
              <a:rPr lang="en-US" sz="900" b="1" dirty="0"/>
              <a:t>C.  </a:t>
            </a:r>
            <a:r>
              <a:rPr lang="en-US" sz="900" dirty="0"/>
              <a:t>Bar plots of the genes that were significantly affected by substituting </a:t>
            </a:r>
            <a:r>
              <a:rPr lang="en-US" sz="900" i="1" dirty="0"/>
              <a:t>ETV2</a:t>
            </a:r>
            <a:r>
              <a:rPr lang="en-US" sz="900" dirty="0"/>
              <a:t> overexpression for </a:t>
            </a:r>
            <a:r>
              <a:rPr lang="en-US" sz="900" i="1" dirty="0"/>
              <a:t>FLI1</a:t>
            </a:r>
            <a:r>
              <a:rPr lang="en-US" sz="900" dirty="0"/>
              <a:t> and/or </a:t>
            </a:r>
            <a:r>
              <a:rPr lang="en-US" sz="900" i="1" dirty="0"/>
              <a:t>ERG</a:t>
            </a:r>
            <a:r>
              <a:rPr lang="en-US" sz="900" dirty="0"/>
              <a:t> lentiviral overexpression. All statistical significances were assessed with a Student’s T-test; * p&lt;0.05, ** p&lt;0.01, *** p&lt;0.001, NS not significant.) (All samples with ERG overexpression: N=2; all other samples: N=3)</a:t>
            </a:r>
            <a:endParaRPr lang="en-GB" sz="900" dirty="0"/>
          </a:p>
        </p:txBody>
      </p:sp>
      <p:sp>
        <p:nvSpPr>
          <p:cNvPr id="16" name="TextBox 15"/>
          <p:cNvSpPr txBox="1"/>
          <p:nvPr/>
        </p:nvSpPr>
        <p:spPr>
          <a:xfrm>
            <a:off x="56665" y="215376"/>
            <a:ext cx="29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A</a:t>
            </a:r>
            <a:endParaRPr lang="en-GB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56665" y="2529393"/>
            <a:ext cx="29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B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758866" y="2529393"/>
            <a:ext cx="29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C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84134" y="454089"/>
            <a:ext cx="1605453" cy="219543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85110" y="454088"/>
            <a:ext cx="1618890" cy="2213805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6"/>
          <a:srcRect l="23959" t="26439" r="11034" b="2990"/>
          <a:stretch/>
        </p:blipFill>
        <p:spPr>
          <a:xfrm>
            <a:off x="263911" y="2849945"/>
            <a:ext cx="1482922" cy="1752544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27372" y="2788019"/>
            <a:ext cx="1185021" cy="181447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02300" y="2788019"/>
            <a:ext cx="1185020" cy="181447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86860" y="2788019"/>
            <a:ext cx="1185020" cy="181447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371881" y="2788019"/>
            <a:ext cx="1185020" cy="1814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37993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2"/>
          <a:srcRect b="6258"/>
          <a:stretch/>
        </p:blipFill>
        <p:spPr>
          <a:xfrm>
            <a:off x="1708818" y="4277153"/>
            <a:ext cx="1575417" cy="1412447"/>
          </a:xfrm>
          <a:prstGeom prst="rect">
            <a:avLst/>
          </a:prstGeom>
        </p:spPr>
      </p:pic>
      <p:sp>
        <p:nvSpPr>
          <p:cNvPr id="47" name="Rectangle 46"/>
          <p:cNvSpPr/>
          <p:nvPr/>
        </p:nvSpPr>
        <p:spPr>
          <a:xfrm>
            <a:off x="718199" y="5812051"/>
            <a:ext cx="3839808" cy="8002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b="1" dirty="0"/>
              <a:t>Supplementary Figure 3. Flow cytometry gating strategy</a:t>
            </a:r>
          </a:p>
          <a:p>
            <a:pPr algn="just"/>
            <a:r>
              <a:rPr lang="en-GB" sz="900" dirty="0"/>
              <a:t>Flow cytometry gating strategy for the measurements of CD32B and MRC1 </a:t>
            </a:r>
            <a:r>
              <a:rPr lang="en-GB" sz="900" b="1" dirty="0"/>
              <a:t>(Figure 6E)</a:t>
            </a:r>
            <a:r>
              <a:rPr lang="en-GB" sz="900" dirty="0"/>
              <a:t>. Arrows indicate the order of subsequent </a:t>
            </a:r>
            <a:r>
              <a:rPr lang="en-GB" sz="900" dirty="0" err="1"/>
              <a:t>gatings</a:t>
            </a:r>
            <a:r>
              <a:rPr lang="en-GB" sz="900" dirty="0"/>
              <a:t>. Red and blue density curves in the final plots represent ETV2-ECs (day 12) and ETV2-SPI1-ECs (day 12) respectively. (FMO: Fluorescence Minus One control).</a:t>
            </a:r>
            <a:endParaRPr lang="en-GB" sz="900" b="1" dirty="0"/>
          </a:p>
        </p:txBody>
      </p:sp>
      <p:pic>
        <p:nvPicPr>
          <p:cNvPr id="5" name="Picture 4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18198" y="519630"/>
            <a:ext cx="1620000" cy="1440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938007" y="519630"/>
            <a:ext cx="1620000" cy="1440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718198" y="2276899"/>
            <a:ext cx="1620000" cy="1440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33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938007" y="2276899"/>
            <a:ext cx="1620000" cy="1440000"/>
          </a:xfrm>
          <a:prstGeom prst="rect">
            <a:avLst/>
          </a:prstGeom>
        </p:spPr>
      </p:pic>
      <p:cxnSp>
        <p:nvCxnSpPr>
          <p:cNvPr id="22" name="Straight Arrow Connector 21"/>
          <p:cNvCxnSpPr>
            <a:stCxn id="5" idx="3"/>
            <a:endCxn id="6" idx="1"/>
          </p:cNvCxnSpPr>
          <p:nvPr/>
        </p:nvCxnSpPr>
        <p:spPr>
          <a:xfrm>
            <a:off x="2338198" y="1239630"/>
            <a:ext cx="59980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V="1">
            <a:off x="2430829" y="2996064"/>
            <a:ext cx="414547" cy="835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Elbow Connector 27"/>
          <p:cNvCxnSpPr>
            <a:stCxn id="6" idx="2"/>
            <a:endCxn id="7" idx="0"/>
          </p:cNvCxnSpPr>
          <p:nvPr/>
        </p:nvCxnSpPr>
        <p:spPr>
          <a:xfrm rot="5400000">
            <a:off x="2479469" y="1008360"/>
            <a:ext cx="317269" cy="2219809"/>
          </a:xfrm>
          <a:prstGeom prst="bentConnector3">
            <a:avLst>
              <a:gd name="adj1" fmla="val 50000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Elbow Connector 32"/>
          <p:cNvCxnSpPr>
            <a:stCxn id="8" idx="2"/>
            <a:endCxn id="20" idx="0"/>
          </p:cNvCxnSpPr>
          <p:nvPr/>
        </p:nvCxnSpPr>
        <p:spPr>
          <a:xfrm rot="5400000">
            <a:off x="2842140" y="3371286"/>
            <a:ext cx="560254" cy="1251480"/>
          </a:xfrm>
          <a:prstGeom prst="bentConnector3">
            <a:avLst>
              <a:gd name="adj1" fmla="val 50000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3575625" y="2236693"/>
            <a:ext cx="4171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FMO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876807" y="2276899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Sample</a:t>
            </a:r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2496526" y="4483944"/>
            <a:ext cx="162095" cy="353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2633726" y="4348976"/>
            <a:ext cx="650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hift</a:t>
            </a:r>
          </a:p>
        </p:txBody>
      </p:sp>
    </p:spTree>
    <p:extLst>
      <p:ext uri="{BB962C8B-B14F-4D97-AF65-F5344CB8AC3E}">
        <p14:creationId xmlns:p14="http://schemas.microsoft.com/office/powerpoint/2010/main" val="23243474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01049" y="271357"/>
            <a:ext cx="3731110" cy="2260492"/>
            <a:chOff x="2339055" y="304226"/>
            <a:chExt cx="3731110" cy="2260492"/>
          </a:xfrm>
        </p:grpSpPr>
        <p:sp>
          <p:nvSpPr>
            <p:cNvPr id="28" name="TextBox 27"/>
            <p:cNvSpPr txBox="1"/>
            <p:nvPr/>
          </p:nvSpPr>
          <p:spPr>
            <a:xfrm>
              <a:off x="5310998" y="304226"/>
              <a:ext cx="565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MRC1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446264" y="870204"/>
              <a:ext cx="655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Isotype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339055" y="1900968"/>
              <a:ext cx="7631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ETV2-ECs</a:t>
              </a:r>
            </a:p>
          </p:txBody>
        </p:sp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84386" y="558704"/>
              <a:ext cx="972000" cy="972000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84386" y="1589468"/>
              <a:ext cx="972000" cy="972000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88657" y="558704"/>
              <a:ext cx="972000" cy="972000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88657" y="1589468"/>
              <a:ext cx="972000" cy="972000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56233" y="558704"/>
              <a:ext cx="900000" cy="900000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66687" y="1589468"/>
              <a:ext cx="900000" cy="900000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>
              <a:off x="3327038" y="305691"/>
              <a:ext cx="518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CD31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306727" y="304227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CD32B</a:t>
              </a:r>
            </a:p>
          </p:txBody>
        </p:sp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96868" y="560141"/>
              <a:ext cx="972000" cy="972000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98165" y="1592718"/>
              <a:ext cx="972000" cy="972000"/>
            </a:xfrm>
            <a:prstGeom prst="rect">
              <a:avLst/>
            </a:prstGeom>
          </p:spPr>
        </p:pic>
      </p:grpSp>
      <p:sp>
        <p:nvSpPr>
          <p:cNvPr id="6" name="TextBox 5"/>
          <p:cNvSpPr txBox="1"/>
          <p:nvPr/>
        </p:nvSpPr>
        <p:spPr>
          <a:xfrm>
            <a:off x="100201" y="143206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A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2737720" y="14320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B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84226" y="2876665"/>
            <a:ext cx="6034001" cy="66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Supplementary Figure 4. Additional characterisation of ETV2-EC endothelial differentiation.</a:t>
            </a:r>
          </a:p>
          <a:p>
            <a:pPr algn="just"/>
            <a:r>
              <a:rPr lang="en-GB" sz="900" b="1" dirty="0"/>
              <a:t>A. </a:t>
            </a:r>
            <a:r>
              <a:rPr lang="en-GB" sz="900" dirty="0"/>
              <a:t>Gene expression (RT-qPCR) of pluripotency markers </a:t>
            </a:r>
            <a:r>
              <a:rPr lang="en-GB" sz="900" i="1" dirty="0"/>
              <a:t>NANOG</a:t>
            </a:r>
            <a:r>
              <a:rPr lang="en-GB" sz="900" dirty="0"/>
              <a:t> and </a:t>
            </a:r>
            <a:r>
              <a:rPr lang="en-GB" sz="900" i="1" dirty="0"/>
              <a:t>POU5F1</a:t>
            </a:r>
            <a:r>
              <a:rPr lang="en-GB" sz="900" dirty="0"/>
              <a:t> throughout a 16-day ETV2-EC endothelial differentiation. </a:t>
            </a:r>
            <a:r>
              <a:rPr lang="en-GB" sz="900" b="1" dirty="0"/>
              <a:t>B. </a:t>
            </a:r>
            <a:r>
              <a:rPr lang="en-GB" sz="900" dirty="0"/>
              <a:t>Immunostaining for the endothelial marker CD31, and the LSEC markers CD32B and MRC1. Similar CD32B perinuclear staining was observed in ETV2-ECs compared to the isotype control.</a:t>
            </a:r>
            <a:endParaRPr lang="en-GB" sz="9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1572" y="525835"/>
            <a:ext cx="2101271" cy="19995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95793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2381773" y="2433999"/>
            <a:ext cx="3780856" cy="3860016"/>
            <a:chOff x="571739" y="1488155"/>
            <a:chExt cx="4500000" cy="4647768"/>
          </a:xfrm>
        </p:grpSpPr>
        <p:pic>
          <p:nvPicPr>
            <p:cNvPr id="11" name="Picture 10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71739" y="1488155"/>
              <a:ext cx="4500000" cy="900000"/>
            </a:xfrm>
            <a:prstGeom prst="rect">
              <a:avLst/>
            </a:prstGeom>
          </p:spPr>
        </p:pic>
        <p:pic>
          <p:nvPicPr>
            <p:cNvPr id="16" name="Picture 15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71739" y="2425097"/>
              <a:ext cx="4500000" cy="900000"/>
            </a:xfrm>
            <a:prstGeom prst="rect">
              <a:avLst/>
            </a:prstGeom>
          </p:spPr>
        </p:pic>
        <p:pic>
          <p:nvPicPr>
            <p:cNvPr id="17" name="Picture 16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1739" y="3362039"/>
              <a:ext cx="4500000" cy="900000"/>
            </a:xfrm>
            <a:prstGeom prst="rect">
              <a:avLst/>
            </a:prstGeom>
          </p:spPr>
        </p:pic>
        <p:pic>
          <p:nvPicPr>
            <p:cNvPr id="18" name="Picture 17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71739" y="4298981"/>
              <a:ext cx="4500000" cy="900000"/>
            </a:xfrm>
            <a:prstGeom prst="rect">
              <a:avLst/>
            </a:prstGeom>
          </p:spPr>
        </p:pic>
        <p:pic>
          <p:nvPicPr>
            <p:cNvPr id="19" name="Picture 18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71739" y="5235923"/>
              <a:ext cx="4500000" cy="900000"/>
            </a:xfrm>
            <a:prstGeom prst="rect">
              <a:avLst/>
            </a:prstGeom>
          </p:spPr>
        </p:pic>
      </p:grpSp>
      <p:sp>
        <p:nvSpPr>
          <p:cNvPr id="10" name="TextBox 9"/>
          <p:cNvSpPr txBox="1"/>
          <p:nvPr/>
        </p:nvSpPr>
        <p:spPr>
          <a:xfrm>
            <a:off x="334350" y="8370863"/>
            <a:ext cx="6039017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Supplementary Figure 5. Expression of putative LSEC markers in single-cell RNA sequencing data</a:t>
            </a:r>
          </a:p>
          <a:p>
            <a:pPr algn="just"/>
            <a:r>
              <a:rPr lang="en-GB" sz="900" b="1" dirty="0"/>
              <a:t>A</a:t>
            </a:r>
            <a:r>
              <a:rPr lang="en-GB" sz="900" dirty="0"/>
              <a:t>. t-SNE representation of the single-cell RNA sequencing data from </a:t>
            </a:r>
            <a:r>
              <a:rPr lang="en-GB" sz="900" dirty="0" err="1"/>
              <a:t>Aizarani</a:t>
            </a:r>
            <a:r>
              <a:rPr lang="en-GB" sz="900" dirty="0"/>
              <a:t> et al. 2019 (</a:t>
            </a:r>
            <a:r>
              <a:rPr lang="en-GB" sz="900" dirty="0" smtClean="0"/>
              <a:t>42). </a:t>
            </a:r>
            <a:r>
              <a:rPr lang="en-GB" sz="900" b="1" dirty="0"/>
              <a:t>B</a:t>
            </a:r>
            <a:r>
              <a:rPr lang="en-GB" sz="900" dirty="0"/>
              <a:t>. Endothelial cells in this dataset were identified by expression of </a:t>
            </a:r>
            <a:r>
              <a:rPr lang="en-GB" sz="900" i="1" dirty="0"/>
              <a:t>CDH5</a:t>
            </a:r>
            <a:r>
              <a:rPr lang="en-GB" sz="900" dirty="0"/>
              <a:t> and </a:t>
            </a:r>
            <a:r>
              <a:rPr lang="en-GB" sz="900" i="1" dirty="0"/>
              <a:t>KDR.  </a:t>
            </a:r>
            <a:r>
              <a:rPr lang="en-GB" sz="900" dirty="0"/>
              <a:t>Genes that were differentially expressed (in the microarray meta-analysis) between LSECs and other endothelial cells were ranked by fold change. Most of the top ranked genes appeared to be specifically expressed in LSECs </a:t>
            </a:r>
            <a:r>
              <a:rPr lang="en-GB" sz="900" b="1" dirty="0"/>
              <a:t>(C)</a:t>
            </a:r>
            <a:r>
              <a:rPr lang="en-GB" sz="900" dirty="0"/>
              <a:t>, while some genes ranked high due to contamination with mRNA of other liver cells </a:t>
            </a:r>
            <a:r>
              <a:rPr lang="en-GB" sz="900" b="1" dirty="0"/>
              <a:t>(D)</a:t>
            </a:r>
            <a:r>
              <a:rPr lang="en-GB" sz="900" dirty="0"/>
              <a:t>. 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50535" y="122627"/>
            <a:ext cx="29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A</a:t>
            </a:r>
            <a:endParaRPr lang="en-GB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2136114" y="2360418"/>
            <a:ext cx="2456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C</a:t>
            </a:r>
            <a:endParaRPr lang="en-GB" sz="1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7"/>
          <a:srcRect r="50595"/>
          <a:stretch/>
        </p:blipFill>
        <p:spPr>
          <a:xfrm>
            <a:off x="464784" y="2581259"/>
            <a:ext cx="1645563" cy="1452135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4350" y="6432716"/>
            <a:ext cx="3849186" cy="818197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7744" y="7284652"/>
            <a:ext cx="3780856" cy="857140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174915" y="6237555"/>
            <a:ext cx="2456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D</a:t>
            </a:r>
            <a:endParaRPr lang="en-GB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150535" y="2360419"/>
            <a:ext cx="29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B</a:t>
            </a:r>
            <a:endParaRPr lang="en-GB" sz="1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9315" y="237261"/>
            <a:ext cx="5665206" cy="2123158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7"/>
          <a:srcRect l="49629"/>
          <a:stretch/>
        </p:blipFill>
        <p:spPr>
          <a:xfrm>
            <a:off x="475042" y="4055398"/>
            <a:ext cx="1677740" cy="1452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86781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29202" y="479211"/>
            <a:ext cx="4467167" cy="3847224"/>
            <a:chOff x="610751" y="2945708"/>
            <a:chExt cx="4035777" cy="444694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10751" y="2945708"/>
              <a:ext cx="4035777" cy="222347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10751" y="5169178"/>
              <a:ext cx="4035777" cy="2223470"/>
            </a:xfrm>
            <a:prstGeom prst="rect">
              <a:avLst/>
            </a:prstGeom>
          </p:spPr>
        </p:pic>
      </p:grpSp>
      <p:sp>
        <p:nvSpPr>
          <p:cNvPr id="8" name="TextBox 7"/>
          <p:cNvSpPr txBox="1"/>
          <p:nvPr/>
        </p:nvSpPr>
        <p:spPr>
          <a:xfrm>
            <a:off x="529202" y="4386815"/>
            <a:ext cx="4552424" cy="815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/>
              <a:t>Supplementary Figure 6. Gene ontology enrichment analysis for each of the WGCNA modules </a:t>
            </a:r>
          </a:p>
          <a:p>
            <a:pPr algn="just"/>
            <a:r>
              <a:rPr lang="en-GB" sz="900" dirty="0"/>
              <a:t>Each of the identified co-expression modules identified by WGCNA was subjected to </a:t>
            </a:r>
            <a:r>
              <a:rPr lang="en-GB" sz="900" dirty="0" err="1"/>
              <a:t>TopGO</a:t>
            </a:r>
            <a:r>
              <a:rPr lang="en-GB" sz="900" dirty="0"/>
              <a:t> Gene Ontology enrichment analysis to identify each module’s function. Gene co-expression modules tend to be highly enriched for specific functionality.</a:t>
            </a:r>
          </a:p>
        </p:txBody>
      </p:sp>
    </p:spTree>
    <p:extLst>
      <p:ext uri="{BB962C8B-B14F-4D97-AF65-F5344CB8AC3E}">
        <p14:creationId xmlns:p14="http://schemas.microsoft.com/office/powerpoint/2010/main" val="33376031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1956" y="496685"/>
            <a:ext cx="2788660" cy="176629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98746" y="6348584"/>
            <a:ext cx="5827734" cy="8002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b="1" dirty="0"/>
              <a:t>Supplementary Figure 7. Time-course RT-qPCR characterisation of ETV2-ECs and ETV2-SPI1-ECs</a:t>
            </a:r>
          </a:p>
          <a:p>
            <a:pPr algn="just"/>
            <a:r>
              <a:rPr lang="en-GB" sz="900" b="1" dirty="0"/>
              <a:t>A</a:t>
            </a:r>
            <a:r>
              <a:rPr lang="en-GB" sz="900" dirty="0"/>
              <a:t>. Expression of pluripotency markers </a:t>
            </a:r>
            <a:r>
              <a:rPr lang="en-GB" sz="900" i="1" dirty="0"/>
              <a:t>NANOG</a:t>
            </a:r>
            <a:r>
              <a:rPr lang="en-GB" sz="900" dirty="0"/>
              <a:t> and </a:t>
            </a:r>
            <a:r>
              <a:rPr lang="en-GB" sz="900" i="1" dirty="0"/>
              <a:t>POU5F1</a:t>
            </a:r>
            <a:r>
              <a:rPr lang="en-GB" sz="900" dirty="0"/>
              <a:t>. </a:t>
            </a:r>
            <a:r>
              <a:rPr lang="en-GB" sz="900" b="1" dirty="0"/>
              <a:t>B. </a:t>
            </a:r>
            <a:r>
              <a:rPr lang="en-GB" sz="900" dirty="0"/>
              <a:t>Expression of overexpressed TFs </a:t>
            </a:r>
            <a:r>
              <a:rPr lang="en-GB" sz="900" i="1" dirty="0"/>
              <a:t>ETV2</a:t>
            </a:r>
            <a:r>
              <a:rPr lang="en-GB" sz="900" dirty="0"/>
              <a:t> and </a:t>
            </a:r>
            <a:r>
              <a:rPr lang="en-GB" sz="900" i="1" dirty="0"/>
              <a:t>SPI1</a:t>
            </a:r>
            <a:r>
              <a:rPr lang="en-GB" sz="900" dirty="0"/>
              <a:t>, of endothelial-specific genes </a:t>
            </a:r>
            <a:r>
              <a:rPr lang="en-GB" sz="900" i="1" dirty="0"/>
              <a:t>CDH5</a:t>
            </a:r>
            <a:r>
              <a:rPr lang="en-GB" sz="900" dirty="0"/>
              <a:t>, </a:t>
            </a:r>
            <a:r>
              <a:rPr lang="en-GB" sz="900" i="1" dirty="0"/>
              <a:t>PECAM1</a:t>
            </a:r>
            <a:r>
              <a:rPr lang="en-GB" sz="900" dirty="0"/>
              <a:t>, and </a:t>
            </a:r>
            <a:r>
              <a:rPr lang="en-GB" sz="900" i="1" dirty="0"/>
              <a:t>VEGFR2</a:t>
            </a:r>
            <a:r>
              <a:rPr lang="en-GB" sz="900" dirty="0"/>
              <a:t>, as well as endothelial-enriched TFs </a:t>
            </a:r>
            <a:r>
              <a:rPr lang="en-GB" sz="900" i="1" dirty="0"/>
              <a:t>FLI1</a:t>
            </a:r>
            <a:r>
              <a:rPr lang="en-GB" sz="900" dirty="0"/>
              <a:t> and </a:t>
            </a:r>
            <a:r>
              <a:rPr lang="en-GB" sz="900" i="1" dirty="0"/>
              <a:t>ERG</a:t>
            </a:r>
            <a:r>
              <a:rPr lang="en-GB" sz="900" dirty="0"/>
              <a:t>. </a:t>
            </a:r>
            <a:r>
              <a:rPr lang="en-GB" sz="900" b="1" dirty="0"/>
              <a:t>C.</a:t>
            </a:r>
            <a:r>
              <a:rPr lang="en-GB" sz="900" dirty="0"/>
              <a:t> Expression of some of the LSEC markers. All statistical differences were assessed by mixed ANOVA. P-values of significant differences between ETCV2-ECs and ETV2-SPI1-ECs are plotted.</a:t>
            </a:r>
            <a:endParaRPr lang="en-GB" sz="9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27184" y="35818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27184" y="227700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32794" y="4222854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C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8746" y="2505746"/>
            <a:ext cx="6559254" cy="1672953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8746" y="4407445"/>
            <a:ext cx="5167345" cy="16992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93973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42997" y="165604"/>
            <a:ext cx="3852127" cy="3970901"/>
            <a:chOff x="842997" y="165604"/>
            <a:chExt cx="3852127" cy="3970901"/>
          </a:xfrm>
        </p:grpSpPr>
        <p:sp>
          <p:nvSpPr>
            <p:cNvPr id="4" name="TextBox 3"/>
            <p:cNvSpPr txBox="1"/>
            <p:nvPr/>
          </p:nvSpPr>
          <p:spPr>
            <a:xfrm>
              <a:off x="3968601" y="186869"/>
              <a:ext cx="5650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MRC1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266766" y="754103"/>
              <a:ext cx="655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Isotype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114569" y="1676118"/>
              <a:ext cx="7631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ETV2-ECs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42997" y="2603552"/>
              <a:ext cx="10897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ETV2-SPI1-ECs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902757" y="3439258"/>
              <a:ext cx="1029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BALB/c LSECs</a:t>
              </a:r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15118" y="453235"/>
              <a:ext cx="900000" cy="9000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15117" y="1375251"/>
              <a:ext cx="900000" cy="9000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15117" y="2307899"/>
              <a:ext cx="900000" cy="90000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15117" y="3236505"/>
              <a:ext cx="900000" cy="90000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2508" y="453235"/>
              <a:ext cx="900000" cy="900000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2507" y="1375251"/>
              <a:ext cx="900000" cy="90000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2507" y="2307899"/>
              <a:ext cx="900000" cy="900000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2507" y="3236505"/>
              <a:ext cx="900000" cy="900000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4671" y="442603"/>
              <a:ext cx="900000" cy="900000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5124" y="1364619"/>
              <a:ext cx="900000" cy="900000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5124" y="2297267"/>
              <a:ext cx="900000" cy="900000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9897" y="3236505"/>
              <a:ext cx="900000" cy="900000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2111990" y="165604"/>
              <a:ext cx="518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CD31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031211" y="173339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CD32B</a:t>
              </a:r>
            </a:p>
          </p:txBody>
        </p:sp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9898" y="453235"/>
              <a:ext cx="900000" cy="900000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9897" y="1375251"/>
              <a:ext cx="900000" cy="900000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9897" y="2307899"/>
              <a:ext cx="900000" cy="900000"/>
            </a:xfrm>
            <a:prstGeom prst="rect">
              <a:avLst/>
            </a:prstGeom>
          </p:spPr>
        </p:pic>
      </p:grpSp>
      <p:sp>
        <p:nvSpPr>
          <p:cNvPr id="32" name="Rectangle 31"/>
          <p:cNvSpPr/>
          <p:nvPr/>
        </p:nvSpPr>
        <p:spPr>
          <a:xfrm>
            <a:off x="805362" y="4274964"/>
            <a:ext cx="4094289" cy="13696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b="1" dirty="0"/>
              <a:t>Supplementary Figure 8. Immunostaining characterisation of ETV2-ECs and ETV2-SPI1-ECs</a:t>
            </a:r>
          </a:p>
          <a:p>
            <a:pPr algn="just"/>
            <a:r>
              <a:rPr lang="en-GB" sz="900" dirty="0"/>
              <a:t>Immunostaining of ETV2-ECs (day 12), ETV2-SPI1-ECs (day 12), and mouse BALB/c LSECs for the endothelial marker CD31, and for the LSEC markers CD32B and MRC1. (Representative images of N=3 biological replicates). Similar CD32B perinuclear staining was observed in ETV2-ECs compared to the isotype control. In ETV2-SPI1-ECs a more homogenous CD32B staining of the entire plasma membrane was observed. (Some images are repeats from Supplementary Figure 4)</a:t>
            </a:r>
            <a:endParaRPr lang="en-GB" sz="900" b="1" dirty="0"/>
          </a:p>
          <a:p>
            <a:pPr algn="just"/>
            <a:endParaRPr lang="en-GB" sz="900" dirty="0"/>
          </a:p>
        </p:txBody>
      </p:sp>
    </p:spTree>
    <p:extLst>
      <p:ext uri="{BB962C8B-B14F-4D97-AF65-F5344CB8AC3E}">
        <p14:creationId xmlns:p14="http://schemas.microsoft.com/office/powerpoint/2010/main" val="3898621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29</TotalTime>
  <Words>688</Words>
  <Application>Microsoft Office PowerPoint</Application>
  <PresentationFormat>A4 Paper (210x297 mm)</PresentationFormat>
  <Paragraphs>43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KULeuv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nuscript LSECs</dc:title>
  <dc:creator>Jonathan De Smedt</dc:creator>
  <cp:lastModifiedBy>Jonathan De Smedt</cp:lastModifiedBy>
  <cp:revision>75</cp:revision>
  <dcterms:created xsi:type="dcterms:W3CDTF">2019-08-26T09:41:57Z</dcterms:created>
  <dcterms:modified xsi:type="dcterms:W3CDTF">2020-08-10T14:04:58Z</dcterms:modified>
</cp:coreProperties>
</file>